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78" y="16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C6C42D-A3B6-4DA5-8E19-1077D1972B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E62347-D00A-4272-ADD2-1F45F3E7F1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35C5A-632E-4F66-B0E5-EE02165D4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521F3E-AED4-4CC4-9710-0FB53C757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F7525A-D407-495D-B8EB-B037A2E23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64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F9C5-975E-491E-B76B-5DB740E7A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753BD6-5EF3-43D4-B749-F9D106956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1D372-4D5A-4225-8F45-3F6ED542AA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CAACCD-2357-463E-B859-01D3493A9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60BBD-333F-4542-9722-A588B0C2B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69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0C398D-1AFA-4D69-A5EF-16F9966C5A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3E5D94-4259-4F44-95E0-5A18456D9B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93615C-AD89-42D6-BB47-38FFEA9DB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43C1B-42F4-4FBA-90B0-C77D73895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90887-113E-4A82-9DDE-FE412C1C0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109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CA2A9A-EF59-48DA-A2CB-AACF96BA3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6E5B42-35AD-428C-B28C-11B1C010F2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2D4334-1EDB-43F7-A7F3-0F34C2F9A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4A294D-4BD7-4593-A2EC-63FB8BD5E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6C08D4-2795-471A-B25C-07000F74C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222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F1715-F6CC-4B61-8633-8FA5FBC74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D91CEA-0502-41FE-A8F9-36D654934B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2FE328-2B27-4019-B360-992E1C477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1A40B1-1E80-4177-8E40-DA09AE8E4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15D99-3041-412A-9233-99E61A860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763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55056-07AF-4554-A79A-4CEC68771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FB5ED9-1B25-491D-8046-678A1F4B04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9D22C6-05BA-41F9-B352-83FC732818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7DF6DA-D7F9-4045-852F-F1E133C73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AE6E77-98D8-49DD-AB20-957FA0B49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412CB8-FB06-45B5-A4F2-50A8CD6F7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793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8FDB1-8C4E-413E-8F75-A08F754E8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D4312C-4120-492C-876D-67AF784B6E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DB83E5-AB43-4491-B459-87BCB22010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C69B9F-E69C-4980-94CD-501099C339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8C906E-C307-4E29-8460-7E14B85134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4CB6BC-078C-4092-9454-651D68C5E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4CF254-0C12-4406-B657-F045BA91C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03F6E5-5021-4323-9B48-DDA01F0E8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2536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4C405-F9C6-4F9D-BB63-F0D3555C6C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A5EEDD-31E3-4CB9-9D6B-A7A52A63F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B3FBE5-6404-44BD-9730-3A4231816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868CDF-592F-43DA-A9F7-B23943757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243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748D8E-6DDC-4C40-BD19-E11157B05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429E7F-D4D2-407D-95B8-1A34925D4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E57196-0CB9-41A5-B110-8CC126E2F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327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017330-DDE7-4A16-AD9F-7AB53CC55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666C7A-9A87-4F61-9F28-FC38FF9B37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A63142-CDBB-40F7-8278-A63F2393DF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2746F0-A650-4883-9D36-EEFAC9FC8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8A6032-A6C4-4D56-81D7-87ABF86F7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AEDF1D-0453-4ED2-AD37-10B18F6FF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104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A539F-E99C-46B9-A41C-C4F99F572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83CE40-DB8E-42C4-AB8B-5C18E314BE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58912A-D792-4992-86A6-6D6723995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754A66-05E0-4E76-8861-0D69BF85E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121D80-6662-4986-AFB3-AB29B53B4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EDE5A5-DFB0-46F3-93C8-8CE4A1C74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4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08CC38-9487-423F-82EF-43CFCA3EF6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50FA04-A530-4609-83E2-96EC844D5E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F99F9B-D73C-44AF-A9A8-FCD88AC44E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4DC9F-A24C-4F73-A8B3-E3079E2013C8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467694-BC87-4FE0-AAE2-5C26432D0A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7C3C8-B25C-43EE-A85E-17A1278086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F212B-2158-4A34-A018-8A784CA355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824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0D8CDA0-E7F1-49C8-B879-B2BBD7698889}"/>
              </a:ext>
            </a:extLst>
          </p:cNvPr>
          <p:cNvSpPr txBox="1"/>
          <p:nvPr/>
        </p:nvSpPr>
        <p:spPr>
          <a:xfrm>
            <a:off x="3279376" y="1456552"/>
            <a:ext cx="8472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IRE1</a:t>
            </a:r>
            <a:r>
              <a:rPr lang="el-G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CDA7B2E-A496-452F-AD41-89D8C9050AF5}"/>
              </a:ext>
            </a:extLst>
          </p:cNvPr>
          <p:cNvSpPr txBox="1"/>
          <p:nvPr/>
        </p:nvSpPr>
        <p:spPr>
          <a:xfrm>
            <a:off x="3235222" y="2782068"/>
            <a:ext cx="70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XBP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A8294D-DF4F-4ECD-B8EA-8FDB2602C81D}"/>
              </a:ext>
            </a:extLst>
          </p:cNvPr>
          <p:cNvSpPr txBox="1"/>
          <p:nvPr/>
        </p:nvSpPr>
        <p:spPr>
          <a:xfrm>
            <a:off x="3321419" y="4694805"/>
            <a:ext cx="8472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00623DA-FF5A-407A-9398-D44F31AA504D}"/>
              </a:ext>
            </a:extLst>
          </p:cNvPr>
          <p:cNvSpPr txBox="1"/>
          <p:nvPr/>
        </p:nvSpPr>
        <p:spPr>
          <a:xfrm>
            <a:off x="3308781" y="3350951"/>
            <a:ext cx="70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217EE4C-5E46-4FFA-888B-ACB6FC6E6860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82" t="4690" r="269" b="3456"/>
          <a:stretch/>
        </p:blipFill>
        <p:spPr>
          <a:xfrm>
            <a:off x="823964" y="4582906"/>
            <a:ext cx="2492294" cy="6216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B78275F-B8E2-4575-8D4E-7AB0FA1F04E3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4" t="4498" r="2792" b="-95"/>
          <a:stretch/>
        </p:blipFill>
        <p:spPr>
          <a:xfrm>
            <a:off x="816487" y="3287432"/>
            <a:ext cx="2492294" cy="5693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CF4F3E7-63D7-4584-8FE5-B7BA5C5A3B9C}"/>
              </a:ext>
            </a:extLst>
          </p:cNvPr>
          <p:cNvSpPr txBox="1"/>
          <p:nvPr/>
        </p:nvSpPr>
        <p:spPr>
          <a:xfrm>
            <a:off x="3394943" y="2150589"/>
            <a:ext cx="70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E1</a:t>
            </a:r>
            <a:r>
              <a:rPr lang="el-G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609AB72-D50C-41A4-B8EE-140B5FB7E790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8" t="8214" r="803" b="12768"/>
          <a:stretch/>
        </p:blipFill>
        <p:spPr>
          <a:xfrm>
            <a:off x="757494" y="1367984"/>
            <a:ext cx="2551470" cy="6777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8A8E073-6858-456D-9B4F-3A43A9D29899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84" t="-200" r="2059" b="1465"/>
          <a:stretch/>
        </p:blipFill>
        <p:spPr>
          <a:xfrm>
            <a:off x="787082" y="2069914"/>
            <a:ext cx="2521882" cy="6216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F8E50CF-4EAB-440D-9A2C-8FA8575FC6EF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2" t="4720" r="-208" b="-2583"/>
          <a:stretch/>
        </p:blipFill>
        <p:spPr>
          <a:xfrm>
            <a:off x="823964" y="3921446"/>
            <a:ext cx="2492294" cy="5600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BE40929-A539-4DC8-A3DA-EEE258A80A49}"/>
              </a:ext>
            </a:extLst>
          </p:cNvPr>
          <p:cNvSpPr txBox="1"/>
          <p:nvPr/>
        </p:nvSpPr>
        <p:spPr>
          <a:xfrm>
            <a:off x="3279376" y="4022878"/>
            <a:ext cx="70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P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176FDFF-CA8C-411D-BA62-3DE12156DD8B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0" t="11005" r="1230" b="-4373"/>
          <a:stretch/>
        </p:blipFill>
        <p:spPr>
          <a:xfrm>
            <a:off x="816487" y="2767492"/>
            <a:ext cx="2418735" cy="4573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3DB01F6-DC29-4BD5-A303-6D140CD19A0C}"/>
              </a:ext>
            </a:extLst>
          </p:cNvPr>
          <p:cNvSpPr txBox="1"/>
          <p:nvPr/>
        </p:nvSpPr>
        <p:spPr>
          <a:xfrm>
            <a:off x="418511" y="4567847"/>
            <a:ext cx="33498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A6F6AAE-B476-4C13-AC00-A06FDD919177}"/>
              </a:ext>
            </a:extLst>
          </p:cNvPr>
          <p:cNvCxnSpPr>
            <a:cxnSpLocks/>
          </p:cNvCxnSpPr>
          <p:nvPr/>
        </p:nvCxnSpPr>
        <p:spPr>
          <a:xfrm>
            <a:off x="838336" y="4646488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D98B9C8-5650-4B3C-B258-B0A127D4B77C}"/>
              </a:ext>
            </a:extLst>
          </p:cNvPr>
          <p:cNvSpPr txBox="1"/>
          <p:nvPr/>
        </p:nvSpPr>
        <p:spPr>
          <a:xfrm>
            <a:off x="418511" y="3416084"/>
            <a:ext cx="4394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0C85AF76-4340-4CAD-A992-A67A4CF0FDD8}"/>
              </a:ext>
            </a:extLst>
          </p:cNvPr>
          <p:cNvCxnSpPr>
            <a:cxnSpLocks/>
          </p:cNvCxnSpPr>
          <p:nvPr/>
        </p:nvCxnSpPr>
        <p:spPr>
          <a:xfrm>
            <a:off x="838336" y="3531595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ECA2EC8-EB60-4001-A7A3-E8723F6346B8}"/>
              </a:ext>
            </a:extLst>
          </p:cNvPr>
          <p:cNvSpPr txBox="1"/>
          <p:nvPr/>
        </p:nvSpPr>
        <p:spPr>
          <a:xfrm>
            <a:off x="418511" y="4166460"/>
            <a:ext cx="3684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F14E352-E465-48F3-A92D-A64E128B9BBB}"/>
              </a:ext>
            </a:extLst>
          </p:cNvPr>
          <p:cNvCxnSpPr>
            <a:cxnSpLocks/>
          </p:cNvCxnSpPr>
          <p:nvPr/>
        </p:nvCxnSpPr>
        <p:spPr>
          <a:xfrm>
            <a:off x="838336" y="4245102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009C06C-7D5A-4362-8403-9151C2F0E314}"/>
              </a:ext>
            </a:extLst>
          </p:cNvPr>
          <p:cNvSpPr txBox="1"/>
          <p:nvPr/>
        </p:nvSpPr>
        <p:spPr>
          <a:xfrm>
            <a:off x="418511" y="2817706"/>
            <a:ext cx="33498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B25A89F-6940-4C4D-A7DF-907D99C3B32D}"/>
              </a:ext>
            </a:extLst>
          </p:cNvPr>
          <p:cNvCxnSpPr>
            <a:cxnSpLocks/>
          </p:cNvCxnSpPr>
          <p:nvPr/>
        </p:nvCxnSpPr>
        <p:spPr>
          <a:xfrm>
            <a:off x="838336" y="2933219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82A354B-459D-4162-A482-B77644B97939}"/>
              </a:ext>
            </a:extLst>
          </p:cNvPr>
          <p:cNvSpPr txBox="1"/>
          <p:nvPr/>
        </p:nvSpPr>
        <p:spPr>
          <a:xfrm>
            <a:off x="418511" y="2396870"/>
            <a:ext cx="4073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AB71E08-FBE6-4144-AE57-61C07A9EE3D9}"/>
              </a:ext>
            </a:extLst>
          </p:cNvPr>
          <p:cNvCxnSpPr>
            <a:cxnSpLocks/>
          </p:cNvCxnSpPr>
          <p:nvPr/>
        </p:nvCxnSpPr>
        <p:spPr>
          <a:xfrm>
            <a:off x="838336" y="2475511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1334365-5B7B-4E6A-B20D-56306D104FD5}"/>
              </a:ext>
            </a:extLst>
          </p:cNvPr>
          <p:cNvCxnSpPr>
            <a:cxnSpLocks/>
          </p:cNvCxnSpPr>
          <p:nvPr/>
        </p:nvCxnSpPr>
        <p:spPr>
          <a:xfrm>
            <a:off x="838336" y="1886498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5B6A34B-CC63-40EF-AC8C-29CD260169EC}"/>
              </a:ext>
            </a:extLst>
          </p:cNvPr>
          <p:cNvSpPr txBox="1"/>
          <p:nvPr/>
        </p:nvSpPr>
        <p:spPr>
          <a:xfrm>
            <a:off x="418511" y="1760516"/>
            <a:ext cx="4073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E9DDB9D-67AF-4C7B-A2A6-BA94AC4EB5C9}"/>
              </a:ext>
            </a:extLst>
          </p:cNvPr>
          <p:cNvSpPr txBox="1"/>
          <p:nvPr/>
        </p:nvSpPr>
        <p:spPr>
          <a:xfrm>
            <a:off x="2192342" y="837009"/>
            <a:ext cx="846810" cy="250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n1</a:t>
            </a:r>
            <a:r>
              <a:rPr lang="en-US" sz="14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K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B6F8C0B-C160-436B-8329-C5FE62392F8B}"/>
              </a:ext>
            </a:extLst>
          </p:cNvPr>
          <p:cNvSpPr txBox="1"/>
          <p:nvPr/>
        </p:nvSpPr>
        <p:spPr>
          <a:xfrm>
            <a:off x="1243876" y="837009"/>
            <a:ext cx="769827" cy="250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n1</a:t>
            </a:r>
            <a:r>
              <a:rPr lang="en-US" sz="140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/fl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6D864BC-DEA3-4AAC-ACA4-88EF0DF42882}"/>
              </a:ext>
            </a:extLst>
          </p:cNvPr>
          <p:cNvCxnSpPr/>
          <p:nvPr/>
        </p:nvCxnSpPr>
        <p:spPr>
          <a:xfrm>
            <a:off x="1175073" y="1109875"/>
            <a:ext cx="89407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195BCB9-3BEB-433A-BB9C-F9CC98E5F1D9}"/>
              </a:ext>
            </a:extLst>
          </p:cNvPr>
          <p:cNvCxnSpPr/>
          <p:nvPr/>
        </p:nvCxnSpPr>
        <p:spPr>
          <a:xfrm>
            <a:off x="2116312" y="1109875"/>
            <a:ext cx="89407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F24E456-818E-4337-A0DB-8694E2104251}"/>
              </a:ext>
            </a:extLst>
          </p:cNvPr>
          <p:cNvSpPr txBox="1"/>
          <p:nvPr/>
        </p:nvSpPr>
        <p:spPr>
          <a:xfrm>
            <a:off x="11141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F293E47-C421-4E34-8541-A1DAF369E938}"/>
              </a:ext>
            </a:extLst>
          </p:cNvPr>
          <p:cNvSpPr txBox="1"/>
          <p:nvPr/>
        </p:nvSpPr>
        <p:spPr>
          <a:xfrm>
            <a:off x="12665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A0F2C24-984D-4217-A266-3AD52767D9D8}"/>
              </a:ext>
            </a:extLst>
          </p:cNvPr>
          <p:cNvSpPr txBox="1"/>
          <p:nvPr/>
        </p:nvSpPr>
        <p:spPr>
          <a:xfrm>
            <a:off x="14189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41C6A63-68DC-49BB-82D2-39F2B5131B96}"/>
              </a:ext>
            </a:extLst>
          </p:cNvPr>
          <p:cNvSpPr txBox="1"/>
          <p:nvPr/>
        </p:nvSpPr>
        <p:spPr>
          <a:xfrm>
            <a:off x="15713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3776C2B-BBD8-4A76-8F75-0AE45521FA7E}"/>
              </a:ext>
            </a:extLst>
          </p:cNvPr>
          <p:cNvSpPr txBox="1"/>
          <p:nvPr/>
        </p:nvSpPr>
        <p:spPr>
          <a:xfrm>
            <a:off x="17237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1E2572E-29BF-4C18-9BC1-EA18C309C422}"/>
              </a:ext>
            </a:extLst>
          </p:cNvPr>
          <p:cNvSpPr txBox="1"/>
          <p:nvPr/>
        </p:nvSpPr>
        <p:spPr>
          <a:xfrm>
            <a:off x="1876113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A86C503-7728-498A-8630-59DB97BD04DC}"/>
              </a:ext>
            </a:extLst>
          </p:cNvPr>
          <p:cNvSpPr txBox="1"/>
          <p:nvPr/>
        </p:nvSpPr>
        <p:spPr>
          <a:xfrm>
            <a:off x="20099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B737470-7BB1-4825-8808-169A2DA3D46A}"/>
              </a:ext>
            </a:extLst>
          </p:cNvPr>
          <p:cNvSpPr txBox="1"/>
          <p:nvPr/>
        </p:nvSpPr>
        <p:spPr>
          <a:xfrm>
            <a:off x="21623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31F62AB-837D-4272-956E-971EEC203F86}"/>
              </a:ext>
            </a:extLst>
          </p:cNvPr>
          <p:cNvSpPr txBox="1"/>
          <p:nvPr/>
        </p:nvSpPr>
        <p:spPr>
          <a:xfrm>
            <a:off x="23147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66847C6-8C16-42A5-89E2-1D6D236FE7FA}"/>
              </a:ext>
            </a:extLst>
          </p:cNvPr>
          <p:cNvSpPr txBox="1"/>
          <p:nvPr/>
        </p:nvSpPr>
        <p:spPr>
          <a:xfrm>
            <a:off x="24671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69E1246-BDD3-4329-A5E1-59617D8EE4E8}"/>
              </a:ext>
            </a:extLst>
          </p:cNvPr>
          <p:cNvSpPr txBox="1"/>
          <p:nvPr/>
        </p:nvSpPr>
        <p:spPr>
          <a:xfrm>
            <a:off x="26195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2535188-7227-440E-9D4D-E96FD3ABA2AC}"/>
              </a:ext>
            </a:extLst>
          </p:cNvPr>
          <p:cNvSpPr txBox="1"/>
          <p:nvPr/>
        </p:nvSpPr>
        <p:spPr>
          <a:xfrm>
            <a:off x="2771926" y="1082040"/>
            <a:ext cx="1736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F9AE062-08A3-421C-BC63-94696733E405}"/>
              </a:ext>
            </a:extLst>
          </p:cNvPr>
          <p:cNvSpPr txBox="1"/>
          <p:nvPr/>
        </p:nvSpPr>
        <p:spPr>
          <a:xfrm>
            <a:off x="3465906" y="686511"/>
            <a:ext cx="1405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: Uninjured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9B85718-C5AD-45DE-A6ED-D5D26F602EF2}"/>
              </a:ext>
            </a:extLst>
          </p:cNvPr>
          <p:cNvSpPr txBox="1"/>
          <p:nvPr/>
        </p:nvSpPr>
        <p:spPr>
          <a:xfrm>
            <a:off x="3465906" y="950911"/>
            <a:ext cx="1405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: 5d-Injure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61D6A33-DE78-45F0-B850-AEFF860EAE3B}"/>
              </a:ext>
            </a:extLst>
          </p:cNvPr>
          <p:cNvSpPr txBox="1"/>
          <p:nvPr/>
        </p:nvSpPr>
        <p:spPr>
          <a:xfrm>
            <a:off x="179624" y="1134721"/>
            <a:ext cx="700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8C1B276-6E1D-468E-9C04-C9176307F9DC}"/>
              </a:ext>
            </a:extLst>
          </p:cNvPr>
          <p:cNvSpPr txBox="1"/>
          <p:nvPr/>
        </p:nvSpPr>
        <p:spPr>
          <a:xfrm>
            <a:off x="34614" y="139069"/>
            <a:ext cx="14055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EV1B</a:t>
            </a:r>
          </a:p>
        </p:txBody>
      </p:sp>
    </p:spTree>
    <p:extLst>
      <p:ext uri="{BB962C8B-B14F-4D97-AF65-F5344CB8AC3E}">
        <p14:creationId xmlns:p14="http://schemas.microsoft.com/office/powerpoint/2010/main" val="2131628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9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4</cp:revision>
  <dcterms:created xsi:type="dcterms:W3CDTF">2024-04-16T15:27:13Z</dcterms:created>
  <dcterms:modified xsi:type="dcterms:W3CDTF">2024-04-16T19:33:23Z</dcterms:modified>
</cp:coreProperties>
</file>